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4" r:id="rId2"/>
    <p:sldId id="299" r:id="rId3"/>
    <p:sldId id="265" r:id="rId4"/>
    <p:sldId id="266" r:id="rId5"/>
  </p:sldIdLst>
  <p:sldSz cx="9144000" cy="8999538"/>
  <p:notesSz cx="6858000" cy="9144000"/>
  <p:custDataLst>
    <p:tags r:id="rId6"/>
  </p:custDataLst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93">
          <p15:clr>
            <a:srgbClr val="A4A3A4"/>
          </p15:clr>
        </p15:guide>
        <p15:guide id="2" pos="27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561" autoAdjust="0"/>
    <p:restoredTop sz="94495" autoAdjust="0"/>
  </p:normalViewPr>
  <p:slideViewPr>
    <p:cSldViewPr>
      <p:cViewPr varScale="1">
        <p:scale>
          <a:sx n="81" d="100"/>
          <a:sy n="81" d="100"/>
        </p:scale>
        <p:origin x="2408" y="192"/>
      </p:cViewPr>
      <p:guideLst>
        <p:guide orient="horz" pos="2893"/>
        <p:guide pos="27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72842"/>
            <a:ext cx="7772400" cy="313317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726842"/>
            <a:ext cx="6858000" cy="217280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E790F-4EF1-74F6-9E9A-8433E7313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46501C-4D5F-5162-395E-D6F3F11F3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D9E1AE-4EB4-6433-33DE-BC7B4EE6B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B9865E-DDB8-B040-9F8C-DFE67195669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5412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6DC85B-E297-9821-E225-47349E06D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B0A269-49CF-A57B-E472-D3F256212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25FC6F-D7A6-EC6D-42E4-1CBAEE79A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2D7FC-86B8-CF4B-8DC5-6B9D0EBE0F3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8484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79142"/>
            <a:ext cx="1971675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79142"/>
            <a:ext cx="5800725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10EEA2-8200-9243-FADE-8F43D96AB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57A33F-04CD-65DC-7CE5-07138D651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7AF56E-C1CD-BB3D-BB76-63F48741F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D2D767-1590-8A49-B67B-967B914D0B6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430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23851B-B66A-12FA-58D9-8492374B7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80104-3B83-FBF9-3708-82450D681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A77989-6E41-E58B-C192-9C913647E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BDD794-C575-5E4E-BB96-5F8E654604E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0817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243638"/>
            <a:ext cx="7886700" cy="374355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022610"/>
            <a:ext cx="7886700" cy="196864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2EECB1-358A-D41E-ABF2-3AEBD33D4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0AEEAA-78B9-6084-B6F9-5E4CBDB9A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852E60-C256-70D5-91A3-9EB502C15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EA88FE-9FA3-334D-AEFA-DB411E14133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6976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D7955A1-96F2-F248-E82A-3C3AA7D31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EB958E63-0C6A-2CA2-3D4F-D50215361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66778608-5B38-E8B7-AA35-BC440BF71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52C507-1ADC-2F4D-8D07-1988263F34D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3603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79144"/>
            <a:ext cx="78867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206137"/>
            <a:ext cx="3868340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287331"/>
            <a:ext cx="3868340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206137"/>
            <a:ext cx="3887391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287331"/>
            <a:ext cx="3887391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EE5BF6F8-F52D-6A26-3C9D-72D265050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5518D6B3-6762-A08A-6FAD-D9E2BEC61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36F6141F-3F5F-F17B-5ECE-C52F5AF4D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AD3241-74D7-F64A-B598-69287180604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0867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687721AD-133C-1C96-C89C-4D6CE1EBB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73CF4646-371F-2E8D-D4A8-F4ADB2E4B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CC7EEDD1-38D2-5E6D-9039-7D82B809D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0ED0B-2919-2749-BD9F-972862910D4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5921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E4FF3EC7-721C-A17D-8B55-A77BCD861D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795EA250-5FFF-B8E9-4D1F-09F7C8099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D42933DD-229B-A4BE-45C3-AFF0CA48A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518A03-55E3-A44A-A909-6AF3A19D0A6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0397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295769"/>
            <a:ext cx="4629150" cy="639550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324010B-BB6C-08C5-97B9-F77B896AE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987A6DBA-42E3-1BC7-AAAD-DB52F7201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185F0A8-A474-B9C9-F5BC-26C0E2343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F7B6C3-FAD1-B247-B6BC-9B251083448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1003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295769"/>
            <a:ext cx="4629150" cy="639550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CN" altLang="en-US" noProof="0"/>
              <a:t>单击图标添加图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839453E-2058-85FF-EA1C-9414941FE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AC783266-4FA5-E1AF-A8A1-3EA5D67E1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AA303638-2193-5BE2-D872-D3779CA79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5370FA-A557-9945-BDED-8CACB631B60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3390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199B8890-4D49-BDE8-44C7-2E7F9ADB9097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479425"/>
            <a:ext cx="7886700" cy="173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F30F0C39-3694-B110-B936-6C1DA5D5D79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28650" y="2395538"/>
            <a:ext cx="7886700" cy="5710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9E59A0-C910-5E4B-A226-D0DE95766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AA3B1E-8587-517E-3C7D-DD19434321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8340725"/>
            <a:ext cx="30861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38A8A4-5015-CF6B-635A-8A23187811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2F81981-DDFA-3049-9C9D-DB02B106842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文本框 30">
            <a:extLst>
              <a:ext uri="{FF2B5EF4-FFF2-40B4-BE49-F238E27FC236}">
                <a16:creationId xmlns:a16="http://schemas.microsoft.com/office/drawing/2014/main" id="{49F55B80-0258-41E8-64F8-E08C518E2C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28749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</a:t>
            </a:r>
            <a:r>
              <a:rPr lang="zh-CN" altLang="en-US" sz="1800"/>
              <a:t>细胞</a:t>
            </a:r>
            <a:r>
              <a:rPr lang="en-US" altLang="zh-CN" sz="1800"/>
              <a:t>cGAS,N=3</a:t>
            </a:r>
          </a:p>
        </p:txBody>
      </p:sp>
      <p:pic>
        <p:nvPicPr>
          <p:cNvPr id="23554" name="图片 3" descr="全膜">
            <a:extLst>
              <a:ext uri="{FF2B5EF4-FFF2-40B4-BE49-F238E27FC236}">
                <a16:creationId xmlns:a16="http://schemas.microsoft.com/office/drawing/2014/main" id="{871CF312-544A-0D27-ADDF-824570BD120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42" t="6882"/>
          <a:stretch>
            <a:fillRect/>
          </a:stretch>
        </p:blipFill>
        <p:spPr bwMode="auto">
          <a:xfrm>
            <a:off x="2555875" y="2627313"/>
            <a:ext cx="4025900" cy="290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555" name="文本框 18">
            <a:extLst>
              <a:ext uri="{FF2B5EF4-FFF2-40B4-BE49-F238E27FC236}">
                <a16:creationId xmlns:a16="http://schemas.microsoft.com/office/drawing/2014/main" id="{9FDDC41A-43E0-F507-5405-2F989E9912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3413" y="2919413"/>
            <a:ext cx="88265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23556" name="文本框 19">
            <a:extLst>
              <a:ext uri="{FF2B5EF4-FFF2-40B4-BE49-F238E27FC236}">
                <a16:creationId xmlns:a16="http://schemas.microsoft.com/office/drawing/2014/main" id="{F3849D6F-564D-F77C-5020-DC1FC58F97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7538" y="3117850"/>
            <a:ext cx="88106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3557" name="文本框 20">
            <a:extLst>
              <a:ext uri="{FF2B5EF4-FFF2-40B4-BE49-F238E27FC236}">
                <a16:creationId xmlns:a16="http://schemas.microsoft.com/office/drawing/2014/main" id="{4DDC2414-9FF2-0B69-FF6A-29088B045A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7538" y="3262313"/>
            <a:ext cx="88106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3558" name="文本框 21">
            <a:extLst>
              <a:ext uri="{FF2B5EF4-FFF2-40B4-BE49-F238E27FC236}">
                <a16:creationId xmlns:a16="http://schemas.microsoft.com/office/drawing/2014/main" id="{4750D739-2072-A4C1-ED5A-3C6C85020A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6438" y="347027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3559" name="文本框 22">
            <a:extLst>
              <a:ext uri="{FF2B5EF4-FFF2-40B4-BE49-F238E27FC236}">
                <a16:creationId xmlns:a16="http://schemas.microsoft.com/office/drawing/2014/main" id="{4A78D899-224A-F876-3103-30F56CE1BB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6438" y="3636963"/>
            <a:ext cx="8112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3560" name="文本框 23">
            <a:extLst>
              <a:ext uri="{FF2B5EF4-FFF2-40B4-BE49-F238E27FC236}">
                <a16:creationId xmlns:a16="http://schemas.microsoft.com/office/drawing/2014/main" id="{873A5743-01EA-A5ED-9B5C-561AE54C78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6438" y="3990975"/>
            <a:ext cx="73660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3561" name="文本框 24">
            <a:extLst>
              <a:ext uri="{FF2B5EF4-FFF2-40B4-BE49-F238E27FC236}">
                <a16:creationId xmlns:a16="http://schemas.microsoft.com/office/drawing/2014/main" id="{D658CDE3-BC38-02FB-B240-EEBCBD8140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0563" y="4262438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3562" name="文本框 25">
            <a:extLst>
              <a:ext uri="{FF2B5EF4-FFF2-40B4-BE49-F238E27FC236}">
                <a16:creationId xmlns:a16="http://schemas.microsoft.com/office/drawing/2014/main" id="{1FFCBF5C-E681-9499-8A15-666FFF2DBD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0563" y="4621213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3563" name="文本框 26">
            <a:extLst>
              <a:ext uri="{FF2B5EF4-FFF2-40B4-BE49-F238E27FC236}">
                <a16:creationId xmlns:a16="http://schemas.microsoft.com/office/drawing/2014/main" id="{17210407-A2CD-7406-2C40-3EDE03F0F8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9613" y="498792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C4D43258-BE33-D400-591A-64BADB05B8DF}"/>
              </a:ext>
            </a:extLst>
          </p:cNvPr>
          <p:cNvSpPr/>
          <p:nvPr/>
        </p:nvSpPr>
        <p:spPr>
          <a:xfrm>
            <a:off x="2805113" y="4140200"/>
            <a:ext cx="3227387" cy="31591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BE697407-9124-6BE7-9BB9-BE07EE29D3F7}"/>
              </a:ext>
            </a:extLst>
          </p:cNvPr>
          <p:cNvSpPr/>
          <p:nvPr/>
        </p:nvSpPr>
        <p:spPr>
          <a:xfrm>
            <a:off x="2805113" y="3492500"/>
            <a:ext cx="3227387" cy="31591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3566" name="文本框 56">
            <a:extLst>
              <a:ext uri="{FF2B5EF4-FFF2-40B4-BE49-F238E27FC236}">
                <a16:creationId xmlns:a16="http://schemas.microsoft.com/office/drawing/2014/main" id="{968985D5-0CC5-EA15-003A-8EB6C7C709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6825" y="4567238"/>
            <a:ext cx="95885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3567" name="文本框 56">
            <a:extLst>
              <a:ext uri="{FF2B5EF4-FFF2-40B4-BE49-F238E27FC236}">
                <a16:creationId xmlns:a16="http://schemas.microsoft.com/office/drawing/2014/main" id="{78428CD6-CA23-2122-23B8-692BC36440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3650" y="3154363"/>
            <a:ext cx="9588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cGAS</a:t>
            </a:r>
          </a:p>
        </p:txBody>
      </p:sp>
      <p:sp>
        <p:nvSpPr>
          <p:cNvPr id="23568" name="文本框 3">
            <a:extLst>
              <a:ext uri="{FF2B5EF4-FFF2-40B4-BE49-F238E27FC236}">
                <a16:creationId xmlns:a16="http://schemas.microsoft.com/office/drawing/2014/main" id="{7AB79946-3A96-8FB7-8A0E-277B94EABA3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855912" y="228123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3569" name="文本框 4">
            <a:extLst>
              <a:ext uri="{FF2B5EF4-FFF2-40B4-BE49-F238E27FC236}">
                <a16:creationId xmlns:a16="http://schemas.microsoft.com/office/drawing/2014/main" id="{CBCCE1B5-2898-4C5F-D44D-FF8D66E7999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96419" y="2229644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3570" name="文本框 5">
            <a:extLst>
              <a:ext uri="{FF2B5EF4-FFF2-40B4-BE49-F238E27FC236}">
                <a16:creationId xmlns:a16="http://schemas.microsoft.com/office/drawing/2014/main" id="{F866A79F-5E92-6BDE-EAF0-72D7386E779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76612" y="228123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3571" name="文本框 6">
            <a:extLst>
              <a:ext uri="{FF2B5EF4-FFF2-40B4-BE49-F238E27FC236}">
                <a16:creationId xmlns:a16="http://schemas.microsoft.com/office/drawing/2014/main" id="{D0E9DC50-8DA8-6520-0070-7B585FD2962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78225" y="2282825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3572" name="文本框 7">
            <a:extLst>
              <a:ext uri="{FF2B5EF4-FFF2-40B4-BE49-F238E27FC236}">
                <a16:creationId xmlns:a16="http://schemas.microsoft.com/office/drawing/2014/main" id="{010E090F-6F69-298E-0333-308CD6B72F5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671093" y="2050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3573" name="文本框 8">
            <a:extLst>
              <a:ext uri="{FF2B5EF4-FFF2-40B4-BE49-F238E27FC236}">
                <a16:creationId xmlns:a16="http://schemas.microsoft.com/office/drawing/2014/main" id="{731C3D57-D5A3-0390-90E8-22C8698715B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940968" y="2050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3574" name="文本框 9">
            <a:extLst>
              <a:ext uri="{FF2B5EF4-FFF2-40B4-BE49-F238E27FC236}">
                <a16:creationId xmlns:a16="http://schemas.microsoft.com/office/drawing/2014/main" id="{171D9C1D-D668-E1CF-3226-92D5BB9CD7E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192587" y="198596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3575" name="文本框 10">
            <a:extLst>
              <a:ext uri="{FF2B5EF4-FFF2-40B4-BE49-F238E27FC236}">
                <a16:creationId xmlns:a16="http://schemas.microsoft.com/office/drawing/2014/main" id="{A730DCF1-53A4-03BE-54E5-B499DF3239D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18012" y="1973263"/>
            <a:ext cx="12477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3576" name="文本框 11">
            <a:extLst>
              <a:ext uri="{FF2B5EF4-FFF2-40B4-BE49-F238E27FC236}">
                <a16:creationId xmlns:a16="http://schemas.microsoft.com/office/drawing/2014/main" id="{61F6D1E0-0533-BDE5-4C87-2F4F7644E77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692650" y="1984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3577" name="文本框 9">
            <a:extLst>
              <a:ext uri="{FF2B5EF4-FFF2-40B4-BE49-F238E27FC236}">
                <a16:creationId xmlns:a16="http://schemas.microsoft.com/office/drawing/2014/main" id="{6317296C-44B4-5582-4081-1330EC051D6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961731" y="1983582"/>
            <a:ext cx="1222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3578" name="文本框 10">
            <a:extLst>
              <a:ext uri="{FF2B5EF4-FFF2-40B4-BE49-F238E27FC236}">
                <a16:creationId xmlns:a16="http://schemas.microsoft.com/office/drawing/2014/main" id="{69BDB320-2987-40CF-7ED4-55302513D90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91919" y="1974057"/>
            <a:ext cx="12461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3579" name="文本框 11">
            <a:extLst>
              <a:ext uri="{FF2B5EF4-FFF2-40B4-BE49-F238E27FC236}">
                <a16:creationId xmlns:a16="http://schemas.microsoft.com/office/drawing/2014/main" id="{719D0D83-C046-1072-D424-C63C991652A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64175" y="1984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7" name="图片 3" descr="sting.tif">
            <a:extLst>
              <a:ext uri="{FF2B5EF4-FFF2-40B4-BE49-F238E27FC236}">
                <a16:creationId xmlns:a16="http://schemas.microsoft.com/office/drawing/2014/main" id="{B87FAAA9-4A3F-A4A7-6E04-00CC47C02E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3" r="8682" b="14716"/>
          <a:stretch>
            <a:fillRect/>
          </a:stretch>
        </p:blipFill>
        <p:spPr bwMode="auto">
          <a:xfrm>
            <a:off x="2482850" y="2124075"/>
            <a:ext cx="4213225" cy="2201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578" name="图片 4" descr="gapdh.tif">
            <a:extLst>
              <a:ext uri="{FF2B5EF4-FFF2-40B4-BE49-F238E27FC236}">
                <a16:creationId xmlns:a16="http://schemas.microsoft.com/office/drawing/2014/main" id="{A21F933E-E456-8280-BBAB-CA45928D80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36" t="8011" r="2438" b="8505"/>
          <a:stretch>
            <a:fillRect/>
          </a:stretch>
        </p:blipFill>
        <p:spPr bwMode="auto">
          <a:xfrm>
            <a:off x="2509838" y="5507038"/>
            <a:ext cx="4222750" cy="2376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579" name="文本框 3">
            <a:extLst>
              <a:ext uri="{FF2B5EF4-FFF2-40B4-BE49-F238E27FC236}">
                <a16:creationId xmlns:a16="http://schemas.microsoft.com/office/drawing/2014/main" id="{AF87C7E0-B7B9-4CCF-156C-BDF628769C2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998787" y="177958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4580" name="文本框 4">
            <a:extLst>
              <a:ext uri="{FF2B5EF4-FFF2-40B4-BE49-F238E27FC236}">
                <a16:creationId xmlns:a16="http://schemas.microsoft.com/office/drawing/2014/main" id="{1FED9366-F69A-5718-DA36-35BB53FC984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239294" y="1727994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4581" name="文本框 5">
            <a:extLst>
              <a:ext uri="{FF2B5EF4-FFF2-40B4-BE49-F238E27FC236}">
                <a16:creationId xmlns:a16="http://schemas.microsoft.com/office/drawing/2014/main" id="{CEE470F3-02E8-23B1-EC73-01A9F214423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19487" y="177958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82" name="文本框 6">
            <a:extLst>
              <a:ext uri="{FF2B5EF4-FFF2-40B4-BE49-F238E27FC236}">
                <a16:creationId xmlns:a16="http://schemas.microsoft.com/office/drawing/2014/main" id="{9FEB06E2-7305-05E3-38C9-6B91A95822A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63975" y="1779588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83" name="文本框 7">
            <a:extLst>
              <a:ext uri="{FF2B5EF4-FFF2-40B4-BE49-F238E27FC236}">
                <a16:creationId xmlns:a16="http://schemas.microsoft.com/office/drawing/2014/main" id="{EB2E45C8-71B2-CEE9-FB13-6BDC221E2D8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958431" y="154860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4584" name="文本框 8">
            <a:extLst>
              <a:ext uri="{FF2B5EF4-FFF2-40B4-BE49-F238E27FC236}">
                <a16:creationId xmlns:a16="http://schemas.microsoft.com/office/drawing/2014/main" id="{EF2DBCDB-9917-0B0A-9E29-AB4E5DE6F5B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28306" y="154860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85" name="文本框 9">
            <a:extLst>
              <a:ext uri="{FF2B5EF4-FFF2-40B4-BE49-F238E27FC236}">
                <a16:creationId xmlns:a16="http://schemas.microsoft.com/office/drawing/2014/main" id="{55D9CBFF-56D3-9F75-302C-18EF24ABA6E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78337" y="1482726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86" name="文本框 10">
            <a:extLst>
              <a:ext uri="{FF2B5EF4-FFF2-40B4-BE49-F238E27FC236}">
                <a16:creationId xmlns:a16="http://schemas.microsoft.com/office/drawing/2014/main" id="{13243825-5764-2517-BA6E-20519826D71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706144" y="1472407"/>
            <a:ext cx="12461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87" name="文本框 11">
            <a:extLst>
              <a:ext uri="{FF2B5EF4-FFF2-40B4-BE49-F238E27FC236}">
                <a16:creationId xmlns:a16="http://schemas.microsoft.com/office/drawing/2014/main" id="{05B4012B-2569-9AC1-DF89-DC8841287DB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978400" y="1481138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88" name="文本框 9">
            <a:extLst>
              <a:ext uri="{FF2B5EF4-FFF2-40B4-BE49-F238E27FC236}">
                <a16:creationId xmlns:a16="http://schemas.microsoft.com/office/drawing/2014/main" id="{342AB6E4-8B40-D831-5645-D13EDB032FC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249862" y="1482726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89" name="文本框 10">
            <a:extLst>
              <a:ext uri="{FF2B5EF4-FFF2-40B4-BE49-F238E27FC236}">
                <a16:creationId xmlns:a16="http://schemas.microsoft.com/office/drawing/2014/main" id="{3BB425C6-085F-14CC-FE6C-DAAA5F836FB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78462" y="1471613"/>
            <a:ext cx="12477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90" name="文本框 11">
            <a:extLst>
              <a:ext uri="{FF2B5EF4-FFF2-40B4-BE49-F238E27FC236}">
                <a16:creationId xmlns:a16="http://schemas.microsoft.com/office/drawing/2014/main" id="{3FFCF113-B2D6-61B0-55D9-680987AC221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52307" y="1483518"/>
            <a:ext cx="12255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91" name="文本框 3">
            <a:extLst>
              <a:ext uri="{FF2B5EF4-FFF2-40B4-BE49-F238E27FC236}">
                <a16:creationId xmlns:a16="http://schemas.microsoft.com/office/drawing/2014/main" id="{B3291C7A-0BA8-11AB-28EB-C872784EE57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982912" y="5135563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4592" name="文本框 4">
            <a:extLst>
              <a:ext uri="{FF2B5EF4-FFF2-40B4-BE49-F238E27FC236}">
                <a16:creationId xmlns:a16="http://schemas.microsoft.com/office/drawing/2014/main" id="{FC4669C2-C5F5-FEFC-D23D-5F81C58AA19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223419" y="5083969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4593" name="文本框 5">
            <a:extLst>
              <a:ext uri="{FF2B5EF4-FFF2-40B4-BE49-F238E27FC236}">
                <a16:creationId xmlns:a16="http://schemas.microsoft.com/office/drawing/2014/main" id="{7E1ED57B-37F5-A87C-EDB1-FC9B3640F7D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03612" y="5135563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94" name="文本框 6">
            <a:extLst>
              <a:ext uri="{FF2B5EF4-FFF2-40B4-BE49-F238E27FC236}">
                <a16:creationId xmlns:a16="http://schemas.microsoft.com/office/drawing/2014/main" id="{470441A0-66E5-47B0-E159-9C23563C75E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48100" y="5135563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95" name="文本框 7">
            <a:extLst>
              <a:ext uri="{FF2B5EF4-FFF2-40B4-BE49-F238E27FC236}">
                <a16:creationId xmlns:a16="http://schemas.microsoft.com/office/drawing/2014/main" id="{05D7E442-79DB-EAF0-3396-471B941680E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940968" y="4904582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4596" name="文本框 8">
            <a:extLst>
              <a:ext uri="{FF2B5EF4-FFF2-40B4-BE49-F238E27FC236}">
                <a16:creationId xmlns:a16="http://schemas.microsoft.com/office/drawing/2014/main" id="{ABD5CE1C-E20B-D42D-33B0-656F50AFAF7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10843" y="4904582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97" name="文本框 9">
            <a:extLst>
              <a:ext uri="{FF2B5EF4-FFF2-40B4-BE49-F238E27FC236}">
                <a16:creationId xmlns:a16="http://schemas.microsoft.com/office/drawing/2014/main" id="{13D7332C-74D7-B972-D0C0-080E712A64F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62462" y="4838701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98" name="文本框 10">
            <a:extLst>
              <a:ext uri="{FF2B5EF4-FFF2-40B4-BE49-F238E27FC236}">
                <a16:creationId xmlns:a16="http://schemas.microsoft.com/office/drawing/2014/main" id="{76983B41-6804-8EB1-59C5-BE5023A82B8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687887" y="4827588"/>
            <a:ext cx="12477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599" name="文本框 11">
            <a:extLst>
              <a:ext uri="{FF2B5EF4-FFF2-40B4-BE49-F238E27FC236}">
                <a16:creationId xmlns:a16="http://schemas.microsoft.com/office/drawing/2014/main" id="{3CCE8AEB-3778-E8A2-51A2-9DEA38533BF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962525" y="4837113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600" name="文本框 9">
            <a:extLst>
              <a:ext uri="{FF2B5EF4-FFF2-40B4-BE49-F238E27FC236}">
                <a16:creationId xmlns:a16="http://schemas.microsoft.com/office/drawing/2014/main" id="{82E20336-2B6E-0F2D-0731-424DB2E9147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233987" y="4838701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601" name="文本框 10">
            <a:extLst>
              <a:ext uri="{FF2B5EF4-FFF2-40B4-BE49-F238E27FC236}">
                <a16:creationId xmlns:a16="http://schemas.microsoft.com/office/drawing/2014/main" id="{FDB06A77-B8F8-C160-46AF-862E37062D7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64175" y="4829176"/>
            <a:ext cx="12461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602" name="文本框 11">
            <a:extLst>
              <a:ext uri="{FF2B5EF4-FFF2-40B4-BE49-F238E27FC236}">
                <a16:creationId xmlns:a16="http://schemas.microsoft.com/office/drawing/2014/main" id="{65F5C5BE-BC1D-928B-5B30-024E8CCEF7B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35638" y="4838700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4603" name="文本框 18">
            <a:extLst>
              <a:ext uri="{FF2B5EF4-FFF2-40B4-BE49-F238E27FC236}">
                <a16:creationId xmlns:a16="http://schemas.microsoft.com/office/drawing/2014/main" id="{C233A7FE-FF39-9456-7E9F-2B867F629D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0538" y="2058988"/>
            <a:ext cx="88265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24604" name="文本框 19">
            <a:extLst>
              <a:ext uri="{FF2B5EF4-FFF2-40B4-BE49-F238E27FC236}">
                <a16:creationId xmlns:a16="http://schemas.microsoft.com/office/drawing/2014/main" id="{0EA6EE69-89D4-5BA5-6DD6-B6B8D550B5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4663" y="2184400"/>
            <a:ext cx="88106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4605" name="文本框 20">
            <a:extLst>
              <a:ext uri="{FF2B5EF4-FFF2-40B4-BE49-F238E27FC236}">
                <a16:creationId xmlns:a16="http://schemas.microsoft.com/office/drawing/2014/main" id="{C0C8506C-36B1-BE76-25E0-EE29C31464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4663" y="2328863"/>
            <a:ext cx="88106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4606" name="文本框 21">
            <a:extLst>
              <a:ext uri="{FF2B5EF4-FFF2-40B4-BE49-F238E27FC236}">
                <a16:creationId xmlns:a16="http://schemas.microsoft.com/office/drawing/2014/main" id="{D700986A-6FF5-0CF3-C628-63164D2E5C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3563" y="253682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4607" name="文本框 22">
            <a:extLst>
              <a:ext uri="{FF2B5EF4-FFF2-40B4-BE49-F238E27FC236}">
                <a16:creationId xmlns:a16="http://schemas.microsoft.com/office/drawing/2014/main" id="{AAEE3672-DE9D-2C5E-C831-8527932911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3563" y="2703513"/>
            <a:ext cx="8112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4608" name="文本框 23">
            <a:extLst>
              <a:ext uri="{FF2B5EF4-FFF2-40B4-BE49-F238E27FC236}">
                <a16:creationId xmlns:a16="http://schemas.microsoft.com/office/drawing/2014/main" id="{12A5BE34-EBD0-4272-E84B-FDE66C0C1D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3563" y="2986088"/>
            <a:ext cx="736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4609" name="文本框 24">
            <a:extLst>
              <a:ext uri="{FF2B5EF4-FFF2-40B4-BE49-F238E27FC236}">
                <a16:creationId xmlns:a16="http://schemas.microsoft.com/office/drawing/2014/main" id="{4FE2644E-1125-79AC-E571-E1AEC1F86C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7688" y="3257550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4610" name="文本框 25">
            <a:extLst>
              <a:ext uri="{FF2B5EF4-FFF2-40B4-BE49-F238E27FC236}">
                <a16:creationId xmlns:a16="http://schemas.microsoft.com/office/drawing/2014/main" id="{0247625F-8AFF-83E0-8600-AA7BB7D22B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7688" y="361632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4611" name="文本框 26">
            <a:extLst>
              <a:ext uri="{FF2B5EF4-FFF2-40B4-BE49-F238E27FC236}">
                <a16:creationId xmlns:a16="http://schemas.microsoft.com/office/drawing/2014/main" id="{4387638D-EC3B-F9C9-38C0-344C88599E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6738" y="3840163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4612" name="文本框 18">
            <a:extLst>
              <a:ext uri="{FF2B5EF4-FFF2-40B4-BE49-F238E27FC236}">
                <a16:creationId xmlns:a16="http://schemas.microsoft.com/office/drawing/2014/main" id="{AFCD089B-D780-47C5-6AFF-333EAC3230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3075" y="5629275"/>
            <a:ext cx="88265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24613" name="文本框 19">
            <a:extLst>
              <a:ext uri="{FF2B5EF4-FFF2-40B4-BE49-F238E27FC236}">
                <a16:creationId xmlns:a16="http://schemas.microsoft.com/office/drawing/2014/main" id="{54E39321-E812-B0B2-AA25-04BFB28439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7200" y="5756275"/>
            <a:ext cx="8810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4614" name="文本框 20">
            <a:extLst>
              <a:ext uri="{FF2B5EF4-FFF2-40B4-BE49-F238E27FC236}">
                <a16:creationId xmlns:a16="http://schemas.microsoft.com/office/drawing/2014/main" id="{33AD3411-135E-A60E-9C48-023B633A38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7200" y="5900738"/>
            <a:ext cx="88106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4615" name="文本框 21">
            <a:extLst>
              <a:ext uri="{FF2B5EF4-FFF2-40B4-BE49-F238E27FC236}">
                <a16:creationId xmlns:a16="http://schemas.microsoft.com/office/drawing/2014/main" id="{292EE8FD-CC53-598C-A4C9-C6B55FCE07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6100" y="61087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4616" name="文本框 22">
            <a:extLst>
              <a:ext uri="{FF2B5EF4-FFF2-40B4-BE49-F238E27FC236}">
                <a16:creationId xmlns:a16="http://schemas.microsoft.com/office/drawing/2014/main" id="{B083A7C6-FA9A-A6A1-28E0-C94D73CBD9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6100" y="6275388"/>
            <a:ext cx="8112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4617" name="文本框 23">
            <a:extLst>
              <a:ext uri="{FF2B5EF4-FFF2-40B4-BE49-F238E27FC236}">
                <a16:creationId xmlns:a16="http://schemas.microsoft.com/office/drawing/2014/main" id="{140D8523-B61E-8EE9-F72C-9ACF80E62B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6100" y="6557963"/>
            <a:ext cx="736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4618" name="文本框 24">
            <a:extLst>
              <a:ext uri="{FF2B5EF4-FFF2-40B4-BE49-F238E27FC236}">
                <a16:creationId xmlns:a16="http://schemas.microsoft.com/office/drawing/2014/main" id="{658305B6-45CF-EF2F-14A8-3E10425EFA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0225" y="6829425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4619" name="文本框 25">
            <a:extLst>
              <a:ext uri="{FF2B5EF4-FFF2-40B4-BE49-F238E27FC236}">
                <a16:creationId xmlns:a16="http://schemas.microsoft.com/office/drawing/2014/main" id="{B2B03FDF-3C22-D869-C450-E59FFD2B2A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0225" y="71882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4620" name="文本框 26">
            <a:extLst>
              <a:ext uri="{FF2B5EF4-FFF2-40B4-BE49-F238E27FC236}">
                <a16:creationId xmlns:a16="http://schemas.microsoft.com/office/drawing/2014/main" id="{E9B7FCF8-4BB2-6185-179B-771438CE6D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9275" y="741045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14FC40A2-9875-8386-BCAA-A8078770BCBC}"/>
              </a:ext>
            </a:extLst>
          </p:cNvPr>
          <p:cNvSpPr/>
          <p:nvPr/>
        </p:nvSpPr>
        <p:spPr>
          <a:xfrm>
            <a:off x="3055938" y="3365500"/>
            <a:ext cx="3300412" cy="27146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2C208010-1145-E268-45DD-178B5ACE8D9E}"/>
              </a:ext>
            </a:extLst>
          </p:cNvPr>
          <p:cNvSpPr/>
          <p:nvPr/>
        </p:nvSpPr>
        <p:spPr>
          <a:xfrm>
            <a:off x="3041650" y="6832600"/>
            <a:ext cx="3394075" cy="3556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4623" name="文本框 16">
            <a:extLst>
              <a:ext uri="{FF2B5EF4-FFF2-40B4-BE49-F238E27FC236}">
                <a16:creationId xmlns:a16="http://schemas.microsoft.com/office/drawing/2014/main" id="{420E0FD5-F421-D7B5-17C5-EBA6F2AA22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92725" y="2955925"/>
            <a:ext cx="860425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STING</a:t>
            </a:r>
          </a:p>
        </p:txBody>
      </p:sp>
      <p:sp>
        <p:nvSpPr>
          <p:cNvPr id="24624" name="文本框 17">
            <a:extLst>
              <a:ext uri="{FF2B5EF4-FFF2-40B4-BE49-F238E27FC236}">
                <a16:creationId xmlns:a16="http://schemas.microsoft.com/office/drawing/2014/main" id="{3B30BC9D-B316-6876-BD6E-DDF9B074AC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2575" y="7169150"/>
            <a:ext cx="109061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4625" name="文本框 16">
            <a:extLst>
              <a:ext uri="{FF2B5EF4-FFF2-40B4-BE49-F238E27FC236}">
                <a16:creationId xmlns:a16="http://schemas.microsoft.com/office/drawing/2014/main" id="{81CAE7D1-EEA8-612E-FE94-289291B57C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825" y="1192213"/>
            <a:ext cx="2286000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/>
              <a:t>H2O2</a:t>
            </a:r>
            <a:r>
              <a:rPr lang="zh-CN" altLang="en-US" sz="1600">
                <a:sym typeface="宋体" panose="02010600030101010101" pitchFamily="2" charset="-122"/>
              </a:rPr>
              <a:t>细胞</a:t>
            </a:r>
            <a:r>
              <a:rPr lang="zh-CN" altLang="en-US" sz="1600"/>
              <a:t>STING,N=3</a:t>
            </a:r>
            <a:endParaRPr lang="en-US" altLang="zh-CN" sz="1600"/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502F707D-FD85-3096-183C-89F600D457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7285" y="4960988"/>
            <a:ext cx="5105035" cy="3260358"/>
          </a:xfrm>
          <a:prstGeom prst="rect">
            <a:avLst/>
          </a:prstGeom>
        </p:spPr>
      </p:pic>
      <p:pic>
        <p:nvPicPr>
          <p:cNvPr id="5" name="图片 4" descr="建筑的设计&#10;&#10;中度可信度描述已自动生成">
            <a:extLst>
              <a:ext uri="{FF2B5EF4-FFF2-40B4-BE49-F238E27FC236}">
                <a16:creationId xmlns:a16="http://schemas.microsoft.com/office/drawing/2014/main" id="{0129933C-DA76-9F44-177C-96C52B65BD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5736" y="1889009"/>
            <a:ext cx="5105035" cy="3474856"/>
          </a:xfrm>
          <a:prstGeom prst="rect">
            <a:avLst/>
          </a:prstGeom>
        </p:spPr>
      </p:pic>
      <p:sp>
        <p:nvSpPr>
          <p:cNvPr id="25601" name="文本框 30">
            <a:extLst>
              <a:ext uri="{FF2B5EF4-FFF2-40B4-BE49-F238E27FC236}">
                <a16:creationId xmlns:a16="http://schemas.microsoft.com/office/drawing/2014/main" id="{EC7EDFC0-0BE2-F215-736E-93A00E22E1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28749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</a:t>
            </a:r>
            <a:r>
              <a:rPr lang="zh-CN" altLang="en-US" sz="1800"/>
              <a:t>细胞</a:t>
            </a:r>
            <a:r>
              <a:rPr lang="en-US" altLang="zh-CN" sz="1800"/>
              <a:t>p-IRF3,IRF3,N=3</a:t>
            </a:r>
          </a:p>
        </p:txBody>
      </p:sp>
      <p:sp>
        <p:nvSpPr>
          <p:cNvPr id="25605" name="文本框 19">
            <a:extLst>
              <a:ext uri="{FF2B5EF4-FFF2-40B4-BE49-F238E27FC236}">
                <a16:creationId xmlns:a16="http://schemas.microsoft.com/office/drawing/2014/main" id="{37CCEEB7-9F7E-AE3A-06F8-347A7E05E4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3225" y="2111549"/>
            <a:ext cx="8810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5606" name="文本框 20">
            <a:extLst>
              <a:ext uri="{FF2B5EF4-FFF2-40B4-BE49-F238E27FC236}">
                <a16:creationId xmlns:a16="http://schemas.microsoft.com/office/drawing/2014/main" id="{6E4253DE-BD6D-D919-4C1B-EFECFEA053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3225" y="2256012"/>
            <a:ext cx="88106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5607" name="文本框 21">
            <a:extLst>
              <a:ext uri="{FF2B5EF4-FFF2-40B4-BE49-F238E27FC236}">
                <a16:creationId xmlns:a16="http://schemas.microsoft.com/office/drawing/2014/main" id="{69F449E2-060B-1D2B-4C28-C0CD7F21C2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2125" y="2463974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5608" name="文本框 22">
            <a:extLst>
              <a:ext uri="{FF2B5EF4-FFF2-40B4-BE49-F238E27FC236}">
                <a16:creationId xmlns:a16="http://schemas.microsoft.com/office/drawing/2014/main" id="{E916A341-FAA9-91E3-C00D-3E49DC54FA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2125" y="2630662"/>
            <a:ext cx="8112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5609" name="文本框 23">
            <a:extLst>
              <a:ext uri="{FF2B5EF4-FFF2-40B4-BE49-F238E27FC236}">
                <a16:creationId xmlns:a16="http://schemas.microsoft.com/office/drawing/2014/main" id="{052482E0-5C8D-AB71-4F4D-171B9DC2AC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2125" y="2771577"/>
            <a:ext cx="73660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5610" name="文本框 24">
            <a:extLst>
              <a:ext uri="{FF2B5EF4-FFF2-40B4-BE49-F238E27FC236}">
                <a16:creationId xmlns:a16="http://schemas.microsoft.com/office/drawing/2014/main" id="{69E08729-C22E-6166-0D61-E0E3CDABF6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6250" y="2987601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5611" name="文本框 25">
            <a:extLst>
              <a:ext uri="{FF2B5EF4-FFF2-40B4-BE49-F238E27FC236}">
                <a16:creationId xmlns:a16="http://schemas.microsoft.com/office/drawing/2014/main" id="{0FC28A9F-46D0-6A5B-E373-DF918DF451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0001" y="3257278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5612" name="文本框 26">
            <a:extLst>
              <a:ext uri="{FF2B5EF4-FFF2-40B4-BE49-F238E27FC236}">
                <a16:creationId xmlns:a16="http://schemas.microsoft.com/office/drawing/2014/main" id="{7E4C3B8D-5FD2-DC03-F6B4-FE2A417058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2485" y="3779689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5614" name="文本框 19">
            <a:extLst>
              <a:ext uri="{FF2B5EF4-FFF2-40B4-BE49-F238E27FC236}">
                <a16:creationId xmlns:a16="http://schemas.microsoft.com/office/drawing/2014/main" id="{E3CDEDBB-D59E-9295-A823-44265579E2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0001" y="5210671"/>
            <a:ext cx="88106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5615" name="文本框 20">
            <a:extLst>
              <a:ext uri="{FF2B5EF4-FFF2-40B4-BE49-F238E27FC236}">
                <a16:creationId xmlns:a16="http://schemas.microsoft.com/office/drawing/2014/main" id="{FBC8A870-76A1-85BD-02B9-FA07601F5E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4446" y="5363865"/>
            <a:ext cx="88106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5616" name="文本框 21">
            <a:extLst>
              <a:ext uri="{FF2B5EF4-FFF2-40B4-BE49-F238E27FC236}">
                <a16:creationId xmlns:a16="http://schemas.microsoft.com/office/drawing/2014/main" id="{587EBF3C-8C3C-5843-8B8A-97971C4204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1181" y="5507881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5617" name="文本框 22">
            <a:extLst>
              <a:ext uri="{FF2B5EF4-FFF2-40B4-BE49-F238E27FC236}">
                <a16:creationId xmlns:a16="http://schemas.microsoft.com/office/drawing/2014/main" id="{C32C3889-22C4-4666-047C-49A3614D63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1181" y="5633541"/>
            <a:ext cx="8112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5618" name="文本框 23">
            <a:extLst>
              <a:ext uri="{FF2B5EF4-FFF2-40B4-BE49-F238E27FC236}">
                <a16:creationId xmlns:a16="http://schemas.microsoft.com/office/drawing/2014/main" id="{36C1A64D-CB35-2F79-A767-2A25717032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3718" y="5806517"/>
            <a:ext cx="736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5619" name="文本框 24">
            <a:extLst>
              <a:ext uri="{FF2B5EF4-FFF2-40B4-BE49-F238E27FC236}">
                <a16:creationId xmlns:a16="http://schemas.microsoft.com/office/drawing/2014/main" id="{8A816C13-EB40-06E1-6CA1-8EBEE30D25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5306" y="5939929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5620" name="文本框 25">
            <a:extLst>
              <a:ext uri="{FF2B5EF4-FFF2-40B4-BE49-F238E27FC236}">
                <a16:creationId xmlns:a16="http://schemas.microsoft.com/office/drawing/2014/main" id="{CE1CF16D-35BF-7C04-C4B3-CEFC91BEF8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5306" y="6227267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5621" name="文本框 26">
            <a:extLst>
              <a:ext uri="{FF2B5EF4-FFF2-40B4-BE49-F238E27FC236}">
                <a16:creationId xmlns:a16="http://schemas.microsoft.com/office/drawing/2014/main" id="{DE824733-4AB1-6C4C-7F8B-68E56133C8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4356" y="680402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8369A18F-2318-E905-FBAE-E31549F9C42D}"/>
              </a:ext>
            </a:extLst>
          </p:cNvPr>
          <p:cNvSpPr/>
          <p:nvPr/>
        </p:nvSpPr>
        <p:spPr>
          <a:xfrm>
            <a:off x="2987675" y="2995259"/>
            <a:ext cx="3814215" cy="31591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5287ADE0-7263-047A-7893-52CE2003F7CE}"/>
              </a:ext>
            </a:extLst>
          </p:cNvPr>
          <p:cNvSpPr/>
          <p:nvPr/>
        </p:nvSpPr>
        <p:spPr>
          <a:xfrm>
            <a:off x="3063844" y="2699569"/>
            <a:ext cx="3738046" cy="25030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5624" name="文本框 56">
            <a:extLst>
              <a:ext uri="{FF2B5EF4-FFF2-40B4-BE49-F238E27FC236}">
                <a16:creationId xmlns:a16="http://schemas.microsoft.com/office/drawing/2014/main" id="{0024391E-ADAA-B935-CDF7-72FC3DD2D6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2397" y="3214171"/>
            <a:ext cx="116363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5625" name="文本框 56">
            <a:extLst>
              <a:ext uri="{FF2B5EF4-FFF2-40B4-BE49-F238E27FC236}">
                <a16:creationId xmlns:a16="http://schemas.microsoft.com/office/drawing/2014/main" id="{5748B12E-51E4-BD5F-526A-8AFC3C2310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9121" y="2287927"/>
            <a:ext cx="11620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 dirty="0">
                <a:solidFill>
                  <a:srgbClr val="FF0000"/>
                </a:solidFill>
                <a:latin typeface="Times New Roman" panose="02020603050405020304" pitchFamily="18" charset="0"/>
              </a:rPr>
              <a:t>p-IRF3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6DAE7D86-E04A-67E4-74F8-A6182532939C}"/>
              </a:ext>
            </a:extLst>
          </p:cNvPr>
          <p:cNvSpPr/>
          <p:nvPr/>
        </p:nvSpPr>
        <p:spPr>
          <a:xfrm>
            <a:off x="3296459" y="6011937"/>
            <a:ext cx="3505431" cy="31591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677D681E-72B2-56E3-A2AA-97BF915C4A07}"/>
              </a:ext>
            </a:extLst>
          </p:cNvPr>
          <p:cNvSpPr/>
          <p:nvPr/>
        </p:nvSpPr>
        <p:spPr>
          <a:xfrm>
            <a:off x="3267232" y="5701684"/>
            <a:ext cx="3534658" cy="31432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5628" name="文本框 56">
            <a:extLst>
              <a:ext uri="{FF2B5EF4-FFF2-40B4-BE49-F238E27FC236}">
                <a16:creationId xmlns:a16="http://schemas.microsoft.com/office/drawing/2014/main" id="{4271A02E-53CF-2CC4-86BF-244C01096D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53172" y="6411934"/>
            <a:ext cx="11620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 dirty="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5629" name="文本框 56">
            <a:extLst>
              <a:ext uri="{FF2B5EF4-FFF2-40B4-BE49-F238E27FC236}">
                <a16:creationId xmlns:a16="http://schemas.microsoft.com/office/drawing/2014/main" id="{0E55F88B-4E1F-2B7A-DF85-CE0BB8925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9216" y="5455970"/>
            <a:ext cx="11620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 dirty="0">
                <a:solidFill>
                  <a:srgbClr val="FF0000"/>
                </a:solidFill>
                <a:latin typeface="Times New Roman" panose="02020603050405020304" pitchFamily="18" charset="0"/>
              </a:rPr>
              <a:t>IRF3</a:t>
            </a:r>
          </a:p>
        </p:txBody>
      </p:sp>
      <p:sp>
        <p:nvSpPr>
          <p:cNvPr id="25630" name="文本框 3">
            <a:extLst>
              <a:ext uri="{FF2B5EF4-FFF2-40B4-BE49-F238E27FC236}">
                <a16:creationId xmlns:a16="http://schemas.microsoft.com/office/drawing/2014/main" id="{93AE0534-12EC-ECBD-8882-464FCC3F626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71018" y="1634332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5631" name="文本框 4">
            <a:extLst>
              <a:ext uri="{FF2B5EF4-FFF2-40B4-BE49-F238E27FC236}">
                <a16:creationId xmlns:a16="http://schemas.microsoft.com/office/drawing/2014/main" id="{5FE421CD-1212-D22C-AD29-4697152674D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13113" y="1584325"/>
            <a:ext cx="644525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5632" name="文本框 5">
            <a:extLst>
              <a:ext uri="{FF2B5EF4-FFF2-40B4-BE49-F238E27FC236}">
                <a16:creationId xmlns:a16="http://schemas.microsoft.com/office/drawing/2014/main" id="{2103DBD4-5548-E78A-76C1-6945B3A5B4D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663156" y="1634332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33" name="文本框 6">
            <a:extLst>
              <a:ext uri="{FF2B5EF4-FFF2-40B4-BE49-F238E27FC236}">
                <a16:creationId xmlns:a16="http://schemas.microsoft.com/office/drawing/2014/main" id="{DC92EA9A-F4AF-D02C-D88D-47CCAEECE5D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008438" y="1636713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34" name="文本框 7">
            <a:extLst>
              <a:ext uri="{FF2B5EF4-FFF2-40B4-BE49-F238E27FC236}">
                <a16:creationId xmlns:a16="http://schemas.microsoft.com/office/drawing/2014/main" id="{99162610-9053-28F3-A488-8A6E20F50AB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173538" y="1406525"/>
            <a:ext cx="1073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5635" name="文本框 8">
            <a:extLst>
              <a:ext uri="{FF2B5EF4-FFF2-40B4-BE49-F238E27FC236}">
                <a16:creationId xmlns:a16="http://schemas.microsoft.com/office/drawing/2014/main" id="{B3225B2B-7B2D-731A-3836-7E28DCDA918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43413" y="1406525"/>
            <a:ext cx="1073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36" name="文本框 9">
            <a:extLst>
              <a:ext uri="{FF2B5EF4-FFF2-40B4-BE49-F238E27FC236}">
                <a16:creationId xmlns:a16="http://schemas.microsoft.com/office/drawing/2014/main" id="{D2D7E189-FE74-DF12-C35A-575C876849A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765675" y="1339851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37" name="文本框 10">
            <a:extLst>
              <a:ext uri="{FF2B5EF4-FFF2-40B4-BE49-F238E27FC236}">
                <a16:creationId xmlns:a16="http://schemas.microsoft.com/office/drawing/2014/main" id="{A3C710B8-6714-457A-9B87-AA5F1DB0A2D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064919" y="1329532"/>
            <a:ext cx="12461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38" name="文本框 11">
            <a:extLst>
              <a:ext uri="{FF2B5EF4-FFF2-40B4-BE49-F238E27FC236}">
                <a16:creationId xmlns:a16="http://schemas.microsoft.com/office/drawing/2014/main" id="{EF58EEB9-87C2-B707-334F-4096020C46C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337175" y="1338263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39" name="文本框 9">
            <a:extLst>
              <a:ext uri="{FF2B5EF4-FFF2-40B4-BE49-F238E27FC236}">
                <a16:creationId xmlns:a16="http://schemas.microsoft.com/office/drawing/2014/main" id="{A0796FDA-7542-165B-EF87-3B6C37DEDAB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679281" y="1339057"/>
            <a:ext cx="1222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40" name="文本框 10">
            <a:extLst>
              <a:ext uri="{FF2B5EF4-FFF2-40B4-BE49-F238E27FC236}">
                <a16:creationId xmlns:a16="http://schemas.microsoft.com/office/drawing/2014/main" id="{6F742093-A3EF-6B41-5547-41DDAF21D02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983288" y="1330325"/>
            <a:ext cx="12461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41" name="文本框 11">
            <a:extLst>
              <a:ext uri="{FF2B5EF4-FFF2-40B4-BE49-F238E27FC236}">
                <a16:creationId xmlns:a16="http://schemas.microsoft.com/office/drawing/2014/main" id="{E0EF2403-6143-DC62-9040-1C8AA169ECE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326188" y="1338263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42" name="文本框 3">
            <a:extLst>
              <a:ext uri="{FF2B5EF4-FFF2-40B4-BE49-F238E27FC236}">
                <a16:creationId xmlns:a16="http://schemas.microsoft.com/office/drawing/2014/main" id="{10DFEC4B-6D75-005A-16BF-7391FB9C78C5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3053556" y="5209456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5643" name="文本框 4">
            <a:extLst>
              <a:ext uri="{FF2B5EF4-FFF2-40B4-BE49-F238E27FC236}">
                <a16:creationId xmlns:a16="http://schemas.microsoft.com/office/drawing/2014/main" id="{41A12E5E-0B97-BD32-7F8C-30015DD8C13A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3294857" y="5158655"/>
            <a:ext cx="646112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5644" name="文本框 5">
            <a:extLst>
              <a:ext uri="{FF2B5EF4-FFF2-40B4-BE49-F238E27FC236}">
                <a16:creationId xmlns:a16="http://schemas.microsoft.com/office/drawing/2014/main" id="{B4D0EAB9-6062-8F13-FCBD-1526F3DB5948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3645693" y="5209456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45" name="文本框 6">
            <a:extLst>
              <a:ext uri="{FF2B5EF4-FFF2-40B4-BE49-F238E27FC236}">
                <a16:creationId xmlns:a16="http://schemas.microsoft.com/office/drawing/2014/main" id="{431A15D5-7410-ECEF-4943-5653BA2D4A0B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3990975" y="5211837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46" name="文本框 7">
            <a:extLst>
              <a:ext uri="{FF2B5EF4-FFF2-40B4-BE49-F238E27FC236}">
                <a16:creationId xmlns:a16="http://schemas.microsoft.com/office/drawing/2014/main" id="{6391758B-0104-84EB-57AA-1372E108BE3E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4157662" y="4980062"/>
            <a:ext cx="10699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5647" name="文本框 8">
            <a:extLst>
              <a:ext uri="{FF2B5EF4-FFF2-40B4-BE49-F238E27FC236}">
                <a16:creationId xmlns:a16="http://schemas.microsoft.com/office/drawing/2014/main" id="{BF4AAF13-BB90-CC11-6D82-A431A322482A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4427537" y="4980062"/>
            <a:ext cx="10699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48" name="文本框 9">
            <a:extLst>
              <a:ext uri="{FF2B5EF4-FFF2-40B4-BE49-F238E27FC236}">
                <a16:creationId xmlns:a16="http://schemas.microsoft.com/office/drawing/2014/main" id="{80A2FBC7-F8EB-DCDF-5BCD-5F24CCAB6C7D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4749800" y="4914975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49" name="文本框 10">
            <a:extLst>
              <a:ext uri="{FF2B5EF4-FFF2-40B4-BE49-F238E27FC236}">
                <a16:creationId xmlns:a16="http://schemas.microsoft.com/office/drawing/2014/main" id="{F57942AD-CFF4-D2AB-D2F8-CB72F3CFF896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5047456" y="4901481"/>
            <a:ext cx="12461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50" name="文本框 11">
            <a:extLst>
              <a:ext uri="{FF2B5EF4-FFF2-40B4-BE49-F238E27FC236}">
                <a16:creationId xmlns:a16="http://schemas.microsoft.com/office/drawing/2014/main" id="{019EA73F-B343-A2DC-A63C-DECE4FE47833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5321300" y="4913387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51" name="文本框 9">
            <a:extLst>
              <a:ext uri="{FF2B5EF4-FFF2-40B4-BE49-F238E27FC236}">
                <a16:creationId xmlns:a16="http://schemas.microsoft.com/office/drawing/2014/main" id="{C65E1672-E116-581A-F127-9641EFE632A5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5664200" y="4913387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52" name="文本框 10">
            <a:extLst>
              <a:ext uri="{FF2B5EF4-FFF2-40B4-BE49-F238E27FC236}">
                <a16:creationId xmlns:a16="http://schemas.microsoft.com/office/drawing/2014/main" id="{42B9180C-FA51-683D-C6C6-A11EC88E6F16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5964237" y="4903862"/>
            <a:ext cx="12477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5653" name="文本框 11">
            <a:extLst>
              <a:ext uri="{FF2B5EF4-FFF2-40B4-BE49-F238E27FC236}">
                <a16:creationId xmlns:a16="http://schemas.microsoft.com/office/drawing/2014/main" id="{BDC8F31B-1BF4-5ED7-9129-64A9E7FDD1A7}"/>
              </a:ext>
            </a:extLst>
          </p:cNvPr>
          <p:cNvSpPr txBox="1">
            <a:spLocks noChangeArrowheads="1"/>
          </p:cNvSpPr>
          <p:nvPr/>
        </p:nvSpPr>
        <p:spPr bwMode="auto">
          <a:xfrm rot="17880000">
            <a:off x="6307932" y="4912592"/>
            <a:ext cx="12255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8" name="文本框 26">
            <a:extLst>
              <a:ext uri="{FF2B5EF4-FFF2-40B4-BE49-F238E27FC236}">
                <a16:creationId xmlns:a16="http://schemas.microsoft.com/office/drawing/2014/main" id="{4D57B2C4-21AB-A688-0729-33526F52CA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2596" y="4479505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10KDa</a:t>
            </a:r>
          </a:p>
        </p:txBody>
      </p:sp>
      <p:sp>
        <p:nvSpPr>
          <p:cNvPr id="9" name="文本框 26">
            <a:extLst>
              <a:ext uri="{FF2B5EF4-FFF2-40B4-BE49-F238E27FC236}">
                <a16:creationId xmlns:a16="http://schemas.microsoft.com/office/drawing/2014/main" id="{ECA6A20F-50C3-0389-C1BB-ABA88562B2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5306" y="7317607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</a:rPr>
              <a:t>10KDa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文本框 30">
            <a:extLst>
              <a:ext uri="{FF2B5EF4-FFF2-40B4-BE49-F238E27FC236}">
                <a16:creationId xmlns:a16="http://schemas.microsoft.com/office/drawing/2014/main" id="{3B7CFCBC-C3AB-F768-8FFE-791D4C4D15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28749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</a:t>
            </a:r>
            <a:r>
              <a:rPr lang="zh-CN" altLang="en-US" sz="1800"/>
              <a:t>细胞</a:t>
            </a:r>
            <a:r>
              <a:rPr lang="en-US" altLang="zh-CN" sz="1800"/>
              <a:t>p-TBK1</a:t>
            </a:r>
            <a:r>
              <a:rPr lang="en-US" altLang="zh-CN" sz="1800">
                <a:sym typeface="宋体" panose="02010600030101010101" pitchFamily="2" charset="-122"/>
              </a:rPr>
              <a:t>,</a:t>
            </a:r>
            <a:r>
              <a:rPr lang="en-US" altLang="zh-CN" sz="1800"/>
              <a:t>N=3</a:t>
            </a:r>
          </a:p>
        </p:txBody>
      </p:sp>
      <p:pic>
        <p:nvPicPr>
          <p:cNvPr id="26626" name="图片 3" descr="P-TBK1.tif">
            <a:extLst>
              <a:ext uri="{FF2B5EF4-FFF2-40B4-BE49-F238E27FC236}">
                <a16:creationId xmlns:a16="http://schemas.microsoft.com/office/drawing/2014/main" id="{A9097DC5-6FE4-EE9A-206C-CB0EAD5CDF5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76" r="2231" b="8934"/>
          <a:stretch>
            <a:fillRect/>
          </a:stretch>
        </p:blipFill>
        <p:spPr bwMode="auto">
          <a:xfrm>
            <a:off x="2555875" y="1979613"/>
            <a:ext cx="4464050" cy="2374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627" name="图片 5" descr="TBK1-Z">
            <a:extLst>
              <a:ext uri="{FF2B5EF4-FFF2-40B4-BE49-F238E27FC236}">
                <a16:creationId xmlns:a16="http://schemas.microsoft.com/office/drawing/2014/main" id="{7B3C99E1-9A0A-EB30-7295-551CE5E6E3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0"/>
          <a:stretch>
            <a:fillRect/>
          </a:stretch>
        </p:blipFill>
        <p:spPr bwMode="auto">
          <a:xfrm>
            <a:off x="2339975" y="5434013"/>
            <a:ext cx="4625975" cy="247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628" name="文本框 18">
            <a:extLst>
              <a:ext uri="{FF2B5EF4-FFF2-40B4-BE49-F238E27FC236}">
                <a16:creationId xmlns:a16="http://schemas.microsoft.com/office/drawing/2014/main" id="{EE6BA274-5939-F759-80D6-EB4B4E70E1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5000" y="2057400"/>
            <a:ext cx="88265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26629" name="文本框 19">
            <a:extLst>
              <a:ext uri="{FF2B5EF4-FFF2-40B4-BE49-F238E27FC236}">
                <a16:creationId xmlns:a16="http://schemas.microsoft.com/office/drawing/2014/main" id="{A44CD1AD-A3CC-6325-53C4-C9FFDEE00F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9125" y="2184400"/>
            <a:ext cx="8810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6630" name="文本框 20">
            <a:extLst>
              <a:ext uri="{FF2B5EF4-FFF2-40B4-BE49-F238E27FC236}">
                <a16:creationId xmlns:a16="http://schemas.microsoft.com/office/drawing/2014/main" id="{E41D389A-0F9F-6251-B95D-18D326279E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9125" y="2328863"/>
            <a:ext cx="88106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6631" name="文本框 21">
            <a:extLst>
              <a:ext uri="{FF2B5EF4-FFF2-40B4-BE49-F238E27FC236}">
                <a16:creationId xmlns:a16="http://schemas.microsoft.com/office/drawing/2014/main" id="{33F27AE7-FD9F-7254-83B5-E4E204E7FF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8025" y="2536825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6632" name="文本框 22">
            <a:extLst>
              <a:ext uri="{FF2B5EF4-FFF2-40B4-BE49-F238E27FC236}">
                <a16:creationId xmlns:a16="http://schemas.microsoft.com/office/drawing/2014/main" id="{0FD25AAC-38AC-4D54-7542-19D24176E2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8025" y="2774950"/>
            <a:ext cx="8112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6633" name="文本框 23">
            <a:extLst>
              <a:ext uri="{FF2B5EF4-FFF2-40B4-BE49-F238E27FC236}">
                <a16:creationId xmlns:a16="http://schemas.microsoft.com/office/drawing/2014/main" id="{2A71781F-E6FE-52AF-76F1-C7BFB4AF9B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8025" y="3057525"/>
            <a:ext cx="73660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6634" name="文本框 24">
            <a:extLst>
              <a:ext uri="{FF2B5EF4-FFF2-40B4-BE49-F238E27FC236}">
                <a16:creationId xmlns:a16="http://schemas.microsoft.com/office/drawing/2014/main" id="{56CC0D55-D5BF-24B0-2EFD-3016EC44EC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2150" y="3328988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6635" name="文本框 25">
            <a:extLst>
              <a:ext uri="{FF2B5EF4-FFF2-40B4-BE49-F238E27FC236}">
                <a16:creationId xmlns:a16="http://schemas.microsoft.com/office/drawing/2014/main" id="{448AA65C-F421-9296-288E-8861E144CF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2150" y="3614738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6636" name="文本框 26">
            <a:extLst>
              <a:ext uri="{FF2B5EF4-FFF2-40B4-BE49-F238E27FC236}">
                <a16:creationId xmlns:a16="http://schemas.microsoft.com/office/drawing/2014/main" id="{BC4C9AC8-01A5-300D-CE86-C6981B69BB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9613" y="3983038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6637" name="文本框 18">
            <a:extLst>
              <a:ext uri="{FF2B5EF4-FFF2-40B4-BE49-F238E27FC236}">
                <a16:creationId xmlns:a16="http://schemas.microsoft.com/office/drawing/2014/main" id="{0323CE8B-B5BF-3033-A33B-E5447679EF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1638" y="5484813"/>
            <a:ext cx="88265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26638" name="文本框 19">
            <a:extLst>
              <a:ext uri="{FF2B5EF4-FFF2-40B4-BE49-F238E27FC236}">
                <a16:creationId xmlns:a16="http://schemas.microsoft.com/office/drawing/2014/main" id="{36179AB0-48AE-3380-F19F-A09B6999CD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5763" y="5611813"/>
            <a:ext cx="88106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6639" name="文本框 20">
            <a:extLst>
              <a:ext uri="{FF2B5EF4-FFF2-40B4-BE49-F238E27FC236}">
                <a16:creationId xmlns:a16="http://schemas.microsoft.com/office/drawing/2014/main" id="{FC186867-747F-8A6B-B459-5E83F002BD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5763" y="5756275"/>
            <a:ext cx="88106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6640" name="文本框 21">
            <a:extLst>
              <a:ext uri="{FF2B5EF4-FFF2-40B4-BE49-F238E27FC236}">
                <a16:creationId xmlns:a16="http://schemas.microsoft.com/office/drawing/2014/main" id="{BF557C1F-2466-44DA-1614-07465A6D11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4663" y="5964238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6641" name="文本框 22">
            <a:extLst>
              <a:ext uri="{FF2B5EF4-FFF2-40B4-BE49-F238E27FC236}">
                <a16:creationId xmlns:a16="http://schemas.microsoft.com/office/drawing/2014/main" id="{04580B5D-A69A-25DF-8C4F-E66E2DB4A4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4663" y="6202363"/>
            <a:ext cx="8112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6642" name="文本框 23">
            <a:extLst>
              <a:ext uri="{FF2B5EF4-FFF2-40B4-BE49-F238E27FC236}">
                <a16:creationId xmlns:a16="http://schemas.microsoft.com/office/drawing/2014/main" id="{D22A0158-B765-0FCA-94D5-FD4B450CDB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4663" y="6484938"/>
            <a:ext cx="736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6643" name="文本框 24">
            <a:extLst>
              <a:ext uri="{FF2B5EF4-FFF2-40B4-BE49-F238E27FC236}">
                <a16:creationId xmlns:a16="http://schemas.microsoft.com/office/drawing/2014/main" id="{62F5606A-9420-FD1A-02A3-F7087F8451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8788" y="682942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6644" name="文本框 25">
            <a:extLst>
              <a:ext uri="{FF2B5EF4-FFF2-40B4-BE49-F238E27FC236}">
                <a16:creationId xmlns:a16="http://schemas.microsoft.com/office/drawing/2014/main" id="{80B0D3DC-D3BD-5456-ABAB-F975F1A7A2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8788" y="711517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6645" name="文本框 26">
            <a:extLst>
              <a:ext uri="{FF2B5EF4-FFF2-40B4-BE49-F238E27FC236}">
                <a16:creationId xmlns:a16="http://schemas.microsoft.com/office/drawing/2014/main" id="{BCA051A4-9F5F-F19D-27D7-4DCC67258B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7838" y="748347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1EA84529-8EFD-0243-AFED-9F0D08F85682}"/>
              </a:ext>
            </a:extLst>
          </p:cNvPr>
          <p:cNvSpPr/>
          <p:nvPr/>
        </p:nvSpPr>
        <p:spPr>
          <a:xfrm>
            <a:off x="2851150" y="3213100"/>
            <a:ext cx="3424238" cy="33337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AB9DD2FE-FF9F-2C72-EBE9-290F0881AE97}"/>
              </a:ext>
            </a:extLst>
          </p:cNvPr>
          <p:cNvSpPr/>
          <p:nvPr/>
        </p:nvSpPr>
        <p:spPr>
          <a:xfrm>
            <a:off x="2916238" y="2490788"/>
            <a:ext cx="3332162" cy="31591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6648" name="文本框 56">
            <a:extLst>
              <a:ext uri="{FF2B5EF4-FFF2-40B4-BE49-F238E27FC236}">
                <a16:creationId xmlns:a16="http://schemas.microsoft.com/office/drawing/2014/main" id="{9A99A273-E5C7-A0E7-36BF-AC373D56E6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51500" y="3705225"/>
            <a:ext cx="973138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6649" name="文本框 56">
            <a:extLst>
              <a:ext uri="{FF2B5EF4-FFF2-40B4-BE49-F238E27FC236}">
                <a16:creationId xmlns:a16="http://schemas.microsoft.com/office/drawing/2014/main" id="{D30AC2E6-66AA-60B9-6BC3-745CEBEA48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5600" y="2122488"/>
            <a:ext cx="97313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p-TBK1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D77D2028-0050-06EA-2AB0-19270D69F9E0}"/>
              </a:ext>
            </a:extLst>
          </p:cNvPr>
          <p:cNvSpPr/>
          <p:nvPr/>
        </p:nvSpPr>
        <p:spPr>
          <a:xfrm>
            <a:off x="2690813" y="6713538"/>
            <a:ext cx="3594100" cy="331787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2136A663-D546-ED63-9CC5-7923F1E4B9A0}"/>
              </a:ext>
            </a:extLst>
          </p:cNvPr>
          <p:cNvSpPr/>
          <p:nvPr/>
        </p:nvSpPr>
        <p:spPr>
          <a:xfrm>
            <a:off x="2755900" y="5918200"/>
            <a:ext cx="3497263" cy="31591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6652" name="文本框 56">
            <a:extLst>
              <a:ext uri="{FF2B5EF4-FFF2-40B4-BE49-F238E27FC236}">
                <a16:creationId xmlns:a16="http://schemas.microsoft.com/office/drawing/2014/main" id="{A1421145-4583-7028-C7AC-73631D9CFA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1163" y="7135813"/>
            <a:ext cx="10207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6653" name="文本框 56">
            <a:extLst>
              <a:ext uri="{FF2B5EF4-FFF2-40B4-BE49-F238E27FC236}">
                <a16:creationId xmlns:a16="http://schemas.microsoft.com/office/drawing/2014/main" id="{825F3ECF-8181-4DCE-C2D4-5F8DF98D2C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5263" y="5551488"/>
            <a:ext cx="10207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TBK1</a:t>
            </a:r>
          </a:p>
        </p:txBody>
      </p:sp>
      <p:sp>
        <p:nvSpPr>
          <p:cNvPr id="26654" name="文本框 3">
            <a:extLst>
              <a:ext uri="{FF2B5EF4-FFF2-40B4-BE49-F238E27FC236}">
                <a16:creationId xmlns:a16="http://schemas.microsoft.com/office/drawing/2014/main" id="{A66A1755-3B44-651C-13CE-B7963813B62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926556" y="1634332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6655" name="文本框 4">
            <a:extLst>
              <a:ext uri="{FF2B5EF4-FFF2-40B4-BE49-F238E27FC236}">
                <a16:creationId xmlns:a16="http://schemas.microsoft.com/office/drawing/2014/main" id="{779FF718-4314-E91D-31F5-E45BD666F1C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167857" y="1583531"/>
            <a:ext cx="646112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6656" name="文本框 5">
            <a:extLst>
              <a:ext uri="{FF2B5EF4-FFF2-40B4-BE49-F238E27FC236}">
                <a16:creationId xmlns:a16="http://schemas.microsoft.com/office/drawing/2014/main" id="{47F85513-CEC0-BD19-A7E7-174094D5336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75818" y="1634332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57" name="文本框 6">
            <a:extLst>
              <a:ext uri="{FF2B5EF4-FFF2-40B4-BE49-F238E27FC236}">
                <a16:creationId xmlns:a16="http://schemas.microsoft.com/office/drawing/2014/main" id="{4FB6F849-D679-8301-ACE3-D9948BBCFBC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649663" y="1636713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58" name="文本框 7">
            <a:extLst>
              <a:ext uri="{FF2B5EF4-FFF2-40B4-BE49-F238E27FC236}">
                <a16:creationId xmlns:a16="http://schemas.microsoft.com/office/drawing/2014/main" id="{42369D08-6FFA-4DF5-1152-FD0CC791769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14763" y="1406525"/>
            <a:ext cx="1073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6659" name="文本框 8">
            <a:extLst>
              <a:ext uri="{FF2B5EF4-FFF2-40B4-BE49-F238E27FC236}">
                <a16:creationId xmlns:a16="http://schemas.microsoft.com/office/drawing/2014/main" id="{D500A00D-6529-272D-20D3-4C2805BABD9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084638" y="1406525"/>
            <a:ext cx="1073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60" name="文本框 9">
            <a:extLst>
              <a:ext uri="{FF2B5EF4-FFF2-40B4-BE49-F238E27FC236}">
                <a16:creationId xmlns:a16="http://schemas.microsoft.com/office/drawing/2014/main" id="{6DE26723-7A71-7E1E-BB91-A632352EB73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64025" y="1339851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61" name="文本框 10">
            <a:extLst>
              <a:ext uri="{FF2B5EF4-FFF2-40B4-BE49-F238E27FC236}">
                <a16:creationId xmlns:a16="http://schemas.microsoft.com/office/drawing/2014/main" id="{052B8AC2-4EE0-B273-A086-70317880F00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60887" y="1328738"/>
            <a:ext cx="12477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62" name="文本框 11">
            <a:extLst>
              <a:ext uri="{FF2B5EF4-FFF2-40B4-BE49-F238E27FC236}">
                <a16:creationId xmlns:a16="http://schemas.microsoft.com/office/drawing/2014/main" id="{26A99BD8-C07A-124C-61E0-A9DA9E20041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835525" y="1338263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63" name="文本框 9">
            <a:extLst>
              <a:ext uri="{FF2B5EF4-FFF2-40B4-BE49-F238E27FC236}">
                <a16:creationId xmlns:a16="http://schemas.microsoft.com/office/drawing/2014/main" id="{EE972780-9B26-B9C2-5D4B-BE581854FF1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06987" y="133826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64" name="文本框 10">
            <a:extLst>
              <a:ext uri="{FF2B5EF4-FFF2-40B4-BE49-F238E27FC236}">
                <a16:creationId xmlns:a16="http://schemas.microsoft.com/office/drawing/2014/main" id="{7E2D1A19-E1C0-19AF-7A62-B36D9150D28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07819" y="1329532"/>
            <a:ext cx="12461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65" name="文本框 11">
            <a:extLst>
              <a:ext uri="{FF2B5EF4-FFF2-40B4-BE49-F238E27FC236}">
                <a16:creationId xmlns:a16="http://schemas.microsoft.com/office/drawing/2014/main" id="{B7CB48A8-546D-EACD-0725-90FA9F4E44B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51513" y="13366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66" name="文本框 3">
            <a:extLst>
              <a:ext uri="{FF2B5EF4-FFF2-40B4-BE49-F238E27FC236}">
                <a16:creationId xmlns:a16="http://schemas.microsoft.com/office/drawing/2014/main" id="{CF11A4E7-0252-0612-6329-52CB29F650B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839243" y="5063332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6667" name="文本框 4">
            <a:extLst>
              <a:ext uri="{FF2B5EF4-FFF2-40B4-BE49-F238E27FC236}">
                <a16:creationId xmlns:a16="http://schemas.microsoft.com/office/drawing/2014/main" id="{72C1A7FE-335C-1D15-800B-9E5183D5AAD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81338" y="5013325"/>
            <a:ext cx="644525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6668" name="文本框 5">
            <a:extLst>
              <a:ext uri="{FF2B5EF4-FFF2-40B4-BE49-F238E27FC236}">
                <a16:creationId xmlns:a16="http://schemas.microsoft.com/office/drawing/2014/main" id="{96A19C37-4655-DEF1-CF30-ECBCB593D27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286918" y="5063332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69" name="文本框 6">
            <a:extLst>
              <a:ext uri="{FF2B5EF4-FFF2-40B4-BE49-F238E27FC236}">
                <a16:creationId xmlns:a16="http://schemas.microsoft.com/office/drawing/2014/main" id="{4E912A57-FB87-4826-94C4-2FDF2EEC8F9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60763" y="5064125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70" name="文本框 7">
            <a:extLst>
              <a:ext uri="{FF2B5EF4-FFF2-40B4-BE49-F238E27FC236}">
                <a16:creationId xmlns:a16="http://schemas.microsoft.com/office/drawing/2014/main" id="{FA3E42D1-8FEE-CE0A-39BB-01B5C59AFBB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726657" y="4833144"/>
            <a:ext cx="10715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6671" name="文本框 8">
            <a:extLst>
              <a:ext uri="{FF2B5EF4-FFF2-40B4-BE49-F238E27FC236}">
                <a16:creationId xmlns:a16="http://schemas.microsoft.com/office/drawing/2014/main" id="{ACA86104-1226-3B12-08DE-2C7F1A4E6AE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996532" y="4833144"/>
            <a:ext cx="10715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72" name="文本框 9">
            <a:extLst>
              <a:ext uri="{FF2B5EF4-FFF2-40B4-BE49-F238E27FC236}">
                <a16:creationId xmlns:a16="http://schemas.microsoft.com/office/drawing/2014/main" id="{9D0159B4-A41E-9CEE-BDBF-7B2F0962282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175125" y="476726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73" name="文本框 10">
            <a:extLst>
              <a:ext uri="{FF2B5EF4-FFF2-40B4-BE49-F238E27FC236}">
                <a16:creationId xmlns:a16="http://schemas.microsoft.com/office/drawing/2014/main" id="{BEE44990-9124-F55A-3712-865C721CF5E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74369" y="4755357"/>
            <a:ext cx="12461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74" name="文本框 11">
            <a:extLst>
              <a:ext uri="{FF2B5EF4-FFF2-40B4-BE49-F238E27FC236}">
                <a16:creationId xmlns:a16="http://schemas.microsoft.com/office/drawing/2014/main" id="{1E326B20-A917-41CF-60F2-F1DDFDDC457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746625" y="47656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75" name="文本框 9">
            <a:extLst>
              <a:ext uri="{FF2B5EF4-FFF2-40B4-BE49-F238E27FC236}">
                <a16:creationId xmlns:a16="http://schemas.microsoft.com/office/drawing/2014/main" id="{B175C45A-5315-FE6B-0593-6A9BC79034B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018087" y="4764088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76" name="文本框 10">
            <a:extLst>
              <a:ext uri="{FF2B5EF4-FFF2-40B4-BE49-F238E27FC236}">
                <a16:creationId xmlns:a16="http://schemas.microsoft.com/office/drawing/2014/main" id="{2CE16575-806D-6375-1CB4-60DB60425B1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318919" y="4755357"/>
            <a:ext cx="12461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6677" name="文本框 11">
            <a:extLst>
              <a:ext uri="{FF2B5EF4-FFF2-40B4-BE49-F238E27FC236}">
                <a16:creationId xmlns:a16="http://schemas.microsoft.com/office/drawing/2014/main" id="{9EC1DC3D-D087-1231-BB08-F640C0E25EF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664200" y="47656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TU2ZjdiN2JjZTY4ZGM3YWFmYzRjMTJiMDJlMzdkODEifQ=="/>
</p:tagLst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9</TotalTime>
  <Words>273</Words>
  <Application>Microsoft Macintosh PowerPoint</Application>
  <PresentationFormat>自定义</PresentationFormat>
  <Paragraphs>16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宋体</vt:lpstr>
      <vt:lpstr>Arial</vt:lpstr>
      <vt:lpstr>Calibri</vt:lpstr>
      <vt:lpstr>Calibri Light</vt:lpstr>
      <vt:lpstr>Times New Roman</vt:lpstr>
      <vt:lpstr>Office 2013 - 2022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cp:lastModifiedBy>18942356872@163.com</cp:lastModifiedBy>
  <cp:revision>80</cp:revision>
  <dcterms:created xsi:type="dcterms:W3CDTF">2024-12-08T09:18:18Z</dcterms:created>
  <dcterms:modified xsi:type="dcterms:W3CDTF">2025-12-20T10:16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321CCEA3293149FF97CD9B16CFEB8259_12</vt:lpwstr>
  </property>
</Properties>
</file>